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26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128.139.16.140\gdrive\Ahan%20Dalal\Flagellin%20paper\Results\Final%20analysi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92D050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0-D9D0-43C2-A051-ADEA803F6D2F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9D0-43C2-A051-ADEA803F6D2F}"/>
              </c:ext>
            </c:extLst>
          </c:dPt>
          <c:errBars>
            <c:errBarType val="both"/>
            <c:errValType val="cust"/>
            <c:noEndCap val="0"/>
            <c:plus>
              <c:numRef>
                <c:f>Sheet3!$Q$38:$Q$39</c:f>
                <c:numCache>
                  <c:formatCode>General</c:formatCode>
                  <c:ptCount val="2"/>
                  <c:pt idx="0">
                    <c:v>0.1079916816</c:v>
                  </c:pt>
                  <c:pt idx="1">
                    <c:v>0.34884013000000003</c:v>
                  </c:pt>
                </c:numCache>
              </c:numRef>
            </c:plus>
            <c:minus>
              <c:numRef>
                <c:f>Sheet3!$Q$38:$Q$39</c:f>
                <c:numCache>
                  <c:formatCode>General</c:formatCode>
                  <c:ptCount val="2"/>
                  <c:pt idx="0">
                    <c:v>0.1079916816</c:v>
                  </c:pt>
                  <c:pt idx="1">
                    <c:v>0.3488401300000000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3!$O$38:$O$39</c:f>
              <c:strCache>
                <c:ptCount val="2"/>
                <c:pt idx="0">
                  <c:v>Mock</c:v>
                </c:pt>
                <c:pt idx="1">
                  <c:v>Flg22</c:v>
                </c:pt>
              </c:strCache>
            </c:strRef>
          </c:cat>
          <c:val>
            <c:numRef>
              <c:f>Sheet3!$P$38:$P$39</c:f>
              <c:numCache>
                <c:formatCode>General</c:formatCode>
                <c:ptCount val="2"/>
                <c:pt idx="0">
                  <c:v>0.78380720299999995</c:v>
                </c:pt>
                <c:pt idx="1">
                  <c:v>2.1823503933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8DA-455C-A448-D31DD11557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5861504"/>
        <c:axId val="195867392"/>
      </c:barChart>
      <c:catAx>
        <c:axId val="1958615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5867392"/>
        <c:crosses val="autoZero"/>
        <c:auto val="1"/>
        <c:lblAlgn val="ctr"/>
        <c:lblOffset val="100"/>
        <c:noMultiLvlLbl val="0"/>
      </c:catAx>
      <c:valAx>
        <c:axId val="1958673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58615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12700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F3358D-B1D7-401E-ABF0-A5EDA59715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095C750-0CDA-4967-A9D5-619D9C9CB3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7F2C3C-FDAB-4A91-8464-5B2BF12139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AE5FE-1DB7-452E-BEE3-4B738D7C14E2}" type="datetimeFigureOut">
              <a:rPr lang="en-US" smtClean="0"/>
              <a:t>31-Dec-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1FBB4E-83AA-4C46-9138-CA567575BD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48D651-A8B7-4465-979B-5ED755F9EA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C649D-A77F-443C-AF81-F7F4A6CB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2360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832CE9-B83E-4798-910A-D3EFF00F34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3E24D07-B083-4D3D-8675-6F1EA9F529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3A90D5-2134-4DD1-BEC2-7C7AE769AD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AE5FE-1DB7-452E-BEE3-4B738D7C14E2}" type="datetimeFigureOut">
              <a:rPr lang="en-US" smtClean="0"/>
              <a:t>31-Dec-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5F44BE-102D-45DF-862F-C296BB5B5A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0F5B6B-BE6C-43CE-AADC-864705C14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C649D-A77F-443C-AF81-F7F4A6CB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061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B039279-518C-4D3D-879B-0C5FF4E3AA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FC86A9D-6EB4-4E49-9E29-2F3CF851A8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ADC4A1-6451-46C5-B503-6E82F56CCC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AE5FE-1DB7-452E-BEE3-4B738D7C14E2}" type="datetimeFigureOut">
              <a:rPr lang="en-US" smtClean="0"/>
              <a:t>31-Dec-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797590-7CE6-42AB-B1A3-D204A610D2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D258CE-8B2F-4B54-8BD4-D2BBD58043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C649D-A77F-443C-AF81-F7F4A6CB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91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FEF277-2DA4-459A-991E-0B1E0957F9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745C9F-08E1-4938-A0FF-F06D31AE7C3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152209-93E0-4532-837E-BF00906417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AE5FE-1DB7-452E-BEE3-4B738D7C14E2}" type="datetimeFigureOut">
              <a:rPr lang="en-US" smtClean="0"/>
              <a:t>31-Dec-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C85D75-334B-4B41-812E-345E2FB38B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C63238-23A5-484D-A0E9-B7B9CBCD44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C649D-A77F-443C-AF81-F7F4A6CB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741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349CE9-EA0E-41CE-A116-5B98B3E3C1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84C924-2AC2-4AFE-9C14-380B5C2857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F99087-0F7A-42E1-8CC5-EEB701EA6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AE5FE-1DB7-452E-BEE3-4B738D7C14E2}" type="datetimeFigureOut">
              <a:rPr lang="en-US" smtClean="0"/>
              <a:t>31-Dec-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783EE3-A177-49BA-BE93-4998841B7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29A373-BEC7-459C-836C-1CA84C6E56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C649D-A77F-443C-AF81-F7F4A6CB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62868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05D6B6-34FC-4F68-9FB5-4DE59A64D2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B5F649-2A38-46EA-9682-A69024041A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51454B-2216-4942-B947-0788775E59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07A78E-B01D-42DD-9A95-519E87A849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AE5FE-1DB7-452E-BEE3-4B738D7C14E2}" type="datetimeFigureOut">
              <a:rPr lang="en-US" smtClean="0"/>
              <a:t>31-Dec-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920939E-999A-4050-80D2-CE27B1F8F8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916F52B-1A58-4318-A2B1-E43D09F76E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C649D-A77F-443C-AF81-F7F4A6CB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4074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279C4E-FD69-4D45-81D5-2B18E1581E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3E6D5F-26D8-48C7-B7BE-0C3DC44435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49113F-A17E-4616-9337-DE6BEB7065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841D7BA-6FE5-4DA2-89FF-B6C2162B9A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E926942-62EC-4BDB-A32E-9B7B6931FE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1DD910F-99A2-4311-990D-6425530CE8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AE5FE-1DB7-452E-BEE3-4B738D7C14E2}" type="datetimeFigureOut">
              <a:rPr lang="en-US" smtClean="0"/>
              <a:t>31-Dec-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B9A8A0F-4F00-4FEA-8E5F-B172F2BE98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DD912FB-3D1E-46A0-9ECF-9552E75F6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C649D-A77F-443C-AF81-F7F4A6CB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470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A5D7AC-B9B9-458A-BD5E-BA6BB4A880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7F7CA72-1F5D-4751-8504-7BC615565B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AE5FE-1DB7-452E-BEE3-4B738D7C14E2}" type="datetimeFigureOut">
              <a:rPr lang="en-US" smtClean="0"/>
              <a:t>31-Dec-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A2EAE5D-4D0A-469F-B0CF-9229F71045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9D4B1B3-63F6-4409-98FD-1187C8A9C8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C649D-A77F-443C-AF81-F7F4A6CB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1485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1F5060E-DF25-4868-A0D3-5002999C26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AE5FE-1DB7-452E-BEE3-4B738D7C14E2}" type="datetimeFigureOut">
              <a:rPr lang="en-US" smtClean="0"/>
              <a:t>31-Dec-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245E5EC-A1B6-4EC6-B08D-638DE51E3E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F848E92-F863-4A67-B2E7-82E904EA58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C649D-A77F-443C-AF81-F7F4A6CB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9542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11EA07-B8F1-48A9-842E-344B09CF06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203146-A0E7-4372-92EB-BA094DD5C72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C730BA-7590-4650-8667-A6C171E258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47632E-3A8D-45A3-823B-4D5C02D284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AE5FE-1DB7-452E-BEE3-4B738D7C14E2}" type="datetimeFigureOut">
              <a:rPr lang="en-US" smtClean="0"/>
              <a:t>31-Dec-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1850B7-CC5A-4B8A-8BCC-D8F0AD9918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66EB31-F0BE-4BF0-93BB-11E7BEF956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C649D-A77F-443C-AF81-F7F4A6CB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8995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B434FF-4002-4F5C-82FB-CDAB16C19D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8A4B4F8-327F-4996-925F-FEE6413FD0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0DA8D2A-CA8E-42B6-AEDA-3E8885A18D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22FD19-CE65-4190-AB3D-F6C6E517F8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AE5FE-1DB7-452E-BEE3-4B738D7C14E2}" type="datetimeFigureOut">
              <a:rPr lang="en-US" smtClean="0"/>
              <a:t>31-Dec-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E210C9-EA38-43CA-B5B7-DBFB593D4C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8F8E83-24A4-4197-A737-5C06E97549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C649D-A77F-443C-AF81-F7F4A6CB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511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6D5C128-D9FD-4C1A-A0F6-CB321F2E66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A881A0-E5A6-4892-849F-842F5A4DDD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98F68E-398E-4DEC-B381-2BD9642F457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7AE5FE-1DB7-452E-BEE3-4B738D7C14E2}" type="datetimeFigureOut">
              <a:rPr lang="en-US" smtClean="0"/>
              <a:t>31-Dec-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B656F0-A9EF-4A3D-BCD0-8046D82174B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59575B-1F46-45B6-AB04-299A3F3EE3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CC649D-A77F-443C-AF81-F7F4A6CB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5456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BD69F3F5-FC39-48B1-B21B-1CAF9D5411F5}"/>
              </a:ext>
            </a:extLst>
          </p:cNvPr>
          <p:cNvGrpSpPr/>
          <p:nvPr/>
        </p:nvGrpSpPr>
        <p:grpSpPr>
          <a:xfrm>
            <a:off x="4638512" y="1563367"/>
            <a:ext cx="992013" cy="932949"/>
            <a:chOff x="5887191" y="1747299"/>
            <a:chExt cx="2282670" cy="2221019"/>
          </a:xfrm>
        </p:grpSpPr>
        <p:pic>
          <p:nvPicPr>
            <p:cNvPr id="5" name="Picture 4" descr="A picture containing fruit, food&#10;&#10;Description automatically generated">
              <a:extLst>
                <a:ext uri="{FF2B5EF4-FFF2-40B4-BE49-F238E27FC236}">
                  <a16:creationId xmlns:a16="http://schemas.microsoft.com/office/drawing/2014/main" id="{AB500F27-B40F-4AE1-982D-D45B668248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694" t="12813" r="30840" b="36261"/>
            <a:stretch/>
          </p:blipFill>
          <p:spPr>
            <a:xfrm>
              <a:off x="5887191" y="1747299"/>
              <a:ext cx="970426" cy="2221019"/>
            </a:xfrm>
            <a:prstGeom prst="rect">
              <a:avLst/>
            </a:prstGeom>
          </p:spPr>
        </p:pic>
        <p:pic>
          <p:nvPicPr>
            <p:cNvPr id="7" name="Picture 7" descr="C:\Users\moran-lab\Desktop\GUS images\xy-flg-myb.jpg">
              <a:extLst>
                <a:ext uri="{FF2B5EF4-FFF2-40B4-BE49-F238E27FC236}">
                  <a16:creationId xmlns:a16="http://schemas.microsoft.com/office/drawing/2014/main" id="{F91E4DC7-B13A-47A6-ACCB-F98336BE424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997" t="9050" r="33259" b="33375"/>
            <a:stretch/>
          </p:blipFill>
          <p:spPr bwMode="auto">
            <a:xfrm>
              <a:off x="7274511" y="1747299"/>
              <a:ext cx="895350" cy="209833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2AE75E44-4961-4D9C-B7FD-B17A62C2DFEB}"/>
              </a:ext>
            </a:extLst>
          </p:cNvPr>
          <p:cNvSpPr txBox="1"/>
          <p:nvPr/>
        </p:nvSpPr>
        <p:spPr>
          <a:xfrm>
            <a:off x="4632812" y="2467654"/>
            <a:ext cx="433132" cy="209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62" b="1" dirty="0"/>
              <a:t>Mock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8FF00B4-634C-4640-AFDD-AE272F97B93F}"/>
              </a:ext>
            </a:extLst>
          </p:cNvPr>
          <p:cNvSpPr txBox="1"/>
          <p:nvPr/>
        </p:nvSpPr>
        <p:spPr>
          <a:xfrm>
            <a:off x="5282337" y="2468895"/>
            <a:ext cx="421910" cy="209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62" b="1" dirty="0"/>
              <a:t>Flg22 </a:t>
            </a:r>
          </a:p>
        </p:txBody>
      </p:sp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A58BBCBD-8026-45E8-BFB9-785EFFFF87F6}"/>
              </a:ext>
            </a:extLst>
          </p:cNvPr>
          <p:cNvGraphicFramePr>
            <a:graphicFrameLocks/>
          </p:cNvGraphicFramePr>
          <p:nvPr/>
        </p:nvGraphicFramePr>
        <p:xfrm>
          <a:off x="4375016" y="642961"/>
          <a:ext cx="1456006" cy="822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1E3177B2-F385-4A53-A367-E0899ACECD83}"/>
              </a:ext>
            </a:extLst>
          </p:cNvPr>
          <p:cNvSpPr txBox="1"/>
          <p:nvPr/>
        </p:nvSpPr>
        <p:spPr>
          <a:xfrm rot="16200000">
            <a:off x="3724620" y="894497"/>
            <a:ext cx="998991" cy="3268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62" b="1" dirty="0"/>
              <a:t>Relative expression </a:t>
            </a:r>
          </a:p>
          <a:p>
            <a:pPr algn="ctr"/>
            <a:r>
              <a:rPr lang="en-US" sz="762" b="1" dirty="0"/>
              <a:t>(folds)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71DBDE83-84FD-46B3-9A5D-55F3119A6CCD}"/>
              </a:ext>
            </a:extLst>
          </p:cNvPr>
          <p:cNvSpPr/>
          <p:nvPr/>
        </p:nvSpPr>
        <p:spPr>
          <a:xfrm>
            <a:off x="4375016" y="1563366"/>
            <a:ext cx="1456006" cy="110467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89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8F0315C-2C6F-4C99-B162-D6DCEDBAD086}"/>
              </a:ext>
            </a:extLst>
          </p:cNvPr>
          <p:cNvSpPr txBox="1"/>
          <p:nvPr/>
        </p:nvSpPr>
        <p:spPr>
          <a:xfrm rot="16200000">
            <a:off x="3906274" y="2005609"/>
            <a:ext cx="745717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1" b="1" dirty="0"/>
              <a:t>GUS staining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78F0240-3550-44C9-B740-2AB6025E2CC9}"/>
              </a:ext>
            </a:extLst>
          </p:cNvPr>
          <p:cNvSpPr txBox="1"/>
          <p:nvPr/>
        </p:nvSpPr>
        <p:spPr>
          <a:xfrm>
            <a:off x="4581702" y="734129"/>
            <a:ext cx="627095" cy="209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62" i="1" dirty="0"/>
              <a:t>ATWRKY3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168C342-E64F-4709-849A-5DB36963631A}"/>
              </a:ext>
            </a:extLst>
          </p:cNvPr>
          <p:cNvSpPr txBox="1"/>
          <p:nvPr/>
        </p:nvSpPr>
        <p:spPr>
          <a:xfrm>
            <a:off x="5317885" y="660034"/>
            <a:ext cx="247184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69" b="1" dirty="0"/>
              <a:t>*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911F430-9218-48A6-8FA4-E123E096AA24}"/>
              </a:ext>
            </a:extLst>
          </p:cNvPr>
          <p:cNvSpPr txBox="1"/>
          <p:nvPr/>
        </p:nvSpPr>
        <p:spPr>
          <a:xfrm>
            <a:off x="3917624" y="574577"/>
            <a:ext cx="248786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1" b="1" dirty="0"/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493CFAE-F32F-41D1-B39A-33E44FE67139}"/>
              </a:ext>
            </a:extLst>
          </p:cNvPr>
          <p:cNvSpPr txBox="1"/>
          <p:nvPr/>
        </p:nvSpPr>
        <p:spPr>
          <a:xfrm>
            <a:off x="3917624" y="1500752"/>
            <a:ext cx="243978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1" b="1" dirty="0"/>
              <a:t>B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67E990F-15B5-407D-9973-27D82E380F62}"/>
              </a:ext>
            </a:extLst>
          </p:cNvPr>
          <p:cNvSpPr txBox="1"/>
          <p:nvPr/>
        </p:nvSpPr>
        <p:spPr>
          <a:xfrm>
            <a:off x="3794940" y="3076477"/>
            <a:ext cx="4562881" cy="7316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831" b="1" dirty="0"/>
              <a:t>Supplementary Figure 1.</a:t>
            </a:r>
            <a:r>
              <a:rPr lang="en-US" sz="831" dirty="0"/>
              <a:t> E</a:t>
            </a:r>
            <a:r>
              <a:rPr lang="en-US" sz="831" dirty="0">
                <a:ea typeface="Calibri" panose="020F0502020204030204" pitchFamily="34" charset="0"/>
              </a:rPr>
              <a:t>ffect of petiole-fed flg22 on </a:t>
            </a:r>
            <a:r>
              <a:rPr lang="en-US" sz="831" b="1" dirty="0">
                <a:ea typeface="Calibri" panose="020F0502020204030204" pitchFamily="34" charset="0"/>
              </a:rPr>
              <a:t>(A)</a:t>
            </a:r>
            <a:r>
              <a:rPr lang="en-US" sz="831" dirty="0">
                <a:ea typeface="Calibri" panose="020F0502020204030204" pitchFamily="34" charset="0"/>
              </a:rPr>
              <a:t> </a:t>
            </a:r>
            <a:r>
              <a:rPr lang="en-US" sz="831" i="1" dirty="0">
                <a:ea typeface="Calibri" panose="020F0502020204030204" pitchFamily="34" charset="0"/>
              </a:rPr>
              <a:t>AtWRKY33</a:t>
            </a:r>
            <a:r>
              <a:rPr lang="en-US" sz="831" dirty="0">
                <a:ea typeface="Calibri" panose="020F0502020204030204" pitchFamily="34" charset="0"/>
              </a:rPr>
              <a:t> expression in WT Arabidopsis leaves as measured using qPCR and </a:t>
            </a:r>
            <a:r>
              <a:rPr lang="en-US" sz="831" b="1" dirty="0">
                <a:ea typeface="Calibri" panose="020F0502020204030204" pitchFamily="34" charset="0"/>
              </a:rPr>
              <a:t>(B)</a:t>
            </a:r>
            <a:r>
              <a:rPr lang="en-US" sz="831" dirty="0">
                <a:ea typeface="Calibri" panose="020F0502020204030204" pitchFamily="34" charset="0"/>
              </a:rPr>
              <a:t> GUS expression in MYB51pro::GUS transgenic Arabidopsis leaves. </a:t>
            </a:r>
            <a:r>
              <a:rPr lang="en-US" sz="831" dirty="0">
                <a:ea typeface="Calibri" panose="020F0502020204030204" pitchFamily="34" charset="0"/>
                <a:cs typeface="Arial" panose="020B0604020202020204" pitchFamily="34" charset="0"/>
              </a:rPr>
              <a:t>Data are shown as means ± SE. An asterisk represents a significant difference between the treatments (Student’s </a:t>
            </a:r>
            <a:r>
              <a:rPr lang="en-US" sz="831" i="1" dirty="0">
                <a:ea typeface="Calibri" panose="020F0502020204030204" pitchFamily="34" charset="0"/>
                <a:cs typeface="Arial" panose="020B0604020202020204" pitchFamily="34" charset="0"/>
              </a:rPr>
              <a:t>t</a:t>
            </a:r>
            <a:r>
              <a:rPr lang="en-US" sz="831" dirty="0">
                <a:ea typeface="Calibri" panose="020F0502020204030204" pitchFamily="34" charset="0"/>
                <a:cs typeface="Arial" panose="020B0604020202020204" pitchFamily="34" charset="0"/>
              </a:rPr>
              <a:t>‐test, </a:t>
            </a:r>
            <a:r>
              <a:rPr lang="en-US" sz="831" i="1" dirty="0"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831" dirty="0">
                <a:ea typeface="Calibri" panose="020F0502020204030204" pitchFamily="34" charset="0"/>
                <a:cs typeface="Arial" panose="020B0604020202020204" pitchFamily="34" charset="0"/>
              </a:rPr>
              <a:t> &lt; 0.05). </a:t>
            </a:r>
            <a:endParaRPr lang="en-US" sz="831" dirty="0"/>
          </a:p>
          <a:p>
            <a:pPr algn="just"/>
            <a:endParaRPr lang="en-US" sz="831" i="1" dirty="0"/>
          </a:p>
        </p:txBody>
      </p:sp>
    </p:spTree>
    <p:extLst>
      <p:ext uri="{BB962C8B-B14F-4D97-AF65-F5344CB8AC3E}">
        <p14:creationId xmlns:p14="http://schemas.microsoft.com/office/powerpoint/2010/main" val="21781690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6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ghaven Basavaraja</dc:creator>
  <cp:lastModifiedBy>Raghaven Basavaraja</cp:lastModifiedBy>
  <cp:revision>1</cp:revision>
  <dcterms:created xsi:type="dcterms:W3CDTF">2020-12-31T12:50:09Z</dcterms:created>
  <dcterms:modified xsi:type="dcterms:W3CDTF">2020-12-31T12:51:12Z</dcterms:modified>
</cp:coreProperties>
</file>